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026" autoAdjust="0"/>
    <p:restoredTop sz="96281" autoAdjust="0"/>
  </p:normalViewPr>
  <p:slideViewPr>
    <p:cSldViewPr>
      <p:cViewPr varScale="1">
        <p:scale>
          <a:sx n="81" d="100"/>
          <a:sy n="81" d="100"/>
        </p:scale>
        <p:origin x="2600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FD5A84-6BB0-4973-8EE5-91D593C036FA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81131D-9DBF-46CB-9DD3-8D7DA16522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780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480x480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81131D-9DBF-46CB-9DD3-8D7DA16522A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256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78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086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2400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4034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353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28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646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0525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160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988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668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7EB87-E86C-4854-98F8-E999C56B31D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1EECF-FEB0-4D7A-B0F1-AFBDBDC2C0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494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35CECE4-3398-43CA-8562-717755049A3C}"/>
              </a:ext>
            </a:extLst>
          </p:cNvPr>
          <p:cNvSpPr txBox="1"/>
          <p:nvPr/>
        </p:nvSpPr>
        <p:spPr>
          <a:xfrm>
            <a:off x="191976" y="83606"/>
            <a:ext cx="2720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97864FD-6445-6F15-7CD0-0D53E0FC5C70}"/>
              </a:ext>
            </a:extLst>
          </p:cNvPr>
          <p:cNvSpPr txBox="1"/>
          <p:nvPr/>
        </p:nvSpPr>
        <p:spPr>
          <a:xfrm>
            <a:off x="522685" y="463099"/>
            <a:ext cx="327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4F8200F-6933-1448-E4AD-F9E20FE58B83}"/>
              </a:ext>
            </a:extLst>
          </p:cNvPr>
          <p:cNvSpPr txBox="1"/>
          <p:nvPr/>
        </p:nvSpPr>
        <p:spPr>
          <a:xfrm>
            <a:off x="2204338" y="434750"/>
            <a:ext cx="2787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verall HCC recurrence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0504066-84AF-6FD7-B7B9-BFDEF5C9D0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158" y="876061"/>
            <a:ext cx="2586856" cy="253523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E921D2E-7920-DDB7-CC7A-2DF7D54777E9}"/>
              </a:ext>
            </a:extLst>
          </p:cNvPr>
          <p:cNvSpPr txBox="1"/>
          <p:nvPr/>
        </p:nvSpPr>
        <p:spPr>
          <a:xfrm>
            <a:off x="522685" y="3570423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9FAF3F9-2793-03EE-DC5B-E462A2369E3A}"/>
              </a:ext>
            </a:extLst>
          </p:cNvPr>
          <p:cNvSpPr txBox="1"/>
          <p:nvPr/>
        </p:nvSpPr>
        <p:spPr>
          <a:xfrm>
            <a:off x="522685" y="6660976"/>
            <a:ext cx="327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9A78640-50F1-C0BD-A990-E62D294BF016}"/>
              </a:ext>
            </a:extLst>
          </p:cNvPr>
          <p:cNvSpPr txBox="1"/>
          <p:nvPr/>
        </p:nvSpPr>
        <p:spPr>
          <a:xfrm>
            <a:off x="2082509" y="3561091"/>
            <a:ext cx="3031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cal tumor progression 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17AA798-169A-EC51-B6FB-76F1E7EFC47C}"/>
              </a:ext>
            </a:extLst>
          </p:cNvPr>
          <p:cNvSpPr txBox="1"/>
          <p:nvPr/>
        </p:nvSpPr>
        <p:spPr>
          <a:xfrm>
            <a:off x="1678553" y="6657832"/>
            <a:ext cx="3839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Intrahepatic distant recurrence  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2E0EA9E1-6F7D-F1FA-44AA-FFFAF97933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158" y="7072480"/>
            <a:ext cx="2586857" cy="2535235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156855AA-8ECA-536F-99DE-D98563C375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2158" y="3972322"/>
            <a:ext cx="2586857" cy="2535235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C61F6F53-3265-F8AC-4FF3-50B0F67446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7987" y="1034741"/>
            <a:ext cx="2411179" cy="2389553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7970E944-8B1F-6E9C-897A-4D4F6BEAEF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8987" y="4120140"/>
            <a:ext cx="2409023" cy="2387417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ECDC5C0C-2C58-929E-DB48-F4C1E3F0B0C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8986" y="7313088"/>
            <a:ext cx="2409024" cy="238741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760C58F-3E5D-A4EF-A22A-539DF7259EB7}"/>
              </a:ext>
            </a:extLst>
          </p:cNvPr>
          <p:cNvSpPr txBox="1"/>
          <p:nvPr/>
        </p:nvSpPr>
        <p:spPr>
          <a:xfrm>
            <a:off x="4619265" y="837516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TX/UL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32D0661-BEF2-D54E-FD77-CD165758D76D}"/>
              </a:ext>
            </a:extLst>
          </p:cNvPr>
          <p:cNvSpPr txBox="1"/>
          <p:nvPr/>
        </p:nvSpPr>
        <p:spPr>
          <a:xfrm>
            <a:off x="4619265" y="3902171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TX/UL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C7FCB72-4567-DD37-CE66-28ADDFE5925D}"/>
              </a:ext>
            </a:extLst>
          </p:cNvPr>
          <p:cNvSpPr txBox="1"/>
          <p:nvPr/>
        </p:nvSpPr>
        <p:spPr>
          <a:xfrm>
            <a:off x="4619265" y="7092366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TX/UL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4784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33</TotalTime>
  <Words>26</Words>
  <Application>Microsoft Macintosh PowerPoint</Application>
  <PresentationFormat>A4 210 x 297 mm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木村 岳史</dc:creator>
  <cp:lastModifiedBy>岩垂 隆諒</cp:lastModifiedBy>
  <cp:revision>86</cp:revision>
  <dcterms:created xsi:type="dcterms:W3CDTF">2022-03-31T08:47:39Z</dcterms:created>
  <dcterms:modified xsi:type="dcterms:W3CDTF">2025-03-02T12:26:46Z</dcterms:modified>
</cp:coreProperties>
</file>